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5" r:id="rId2"/>
    <p:sldId id="311" r:id="rId3"/>
    <p:sldId id="312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585877098226748"/>
          <c:y val="9.3230484574301956E-2"/>
          <c:w val="0.77439432470800873"/>
          <c:h val="0.757892940106051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F7-42D1-BEFE-5BFC3C2E7DD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F7-42D1-BEFE-5BFC3C2E7DDE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F7-42D1-BEFE-5BFC3C2E7DDE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F7-42D1-BEFE-5BFC3C2E7DDE}"/>
              </c:ext>
            </c:extLst>
          </c:dPt>
          <c:dLbls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Time!$AT$14:$AW$14</c:f>
                <c:numCache>
                  <c:formatCode>General</c:formatCode>
                  <c:ptCount val="4"/>
                  <c:pt idx="0">
                    <c:v>0.32882920139486488</c:v>
                  </c:pt>
                  <c:pt idx="1">
                    <c:v>0.18218401436230147</c:v>
                  </c:pt>
                  <c:pt idx="2">
                    <c:v>0.21708594482762092</c:v>
                  </c:pt>
                  <c:pt idx="3">
                    <c:v>0.33469372605507697</c:v>
                  </c:pt>
                </c:numCache>
              </c:numRef>
            </c:plus>
            <c:minus>
              <c:numRef>
                <c:f>Time!$AT$14:$AW$14</c:f>
                <c:numCache>
                  <c:formatCode>General</c:formatCode>
                  <c:ptCount val="4"/>
                  <c:pt idx="0">
                    <c:v>0.32882920139486488</c:v>
                  </c:pt>
                  <c:pt idx="1">
                    <c:v>0.18218401436230147</c:v>
                  </c:pt>
                  <c:pt idx="2">
                    <c:v>0.21708594482762092</c:v>
                  </c:pt>
                  <c:pt idx="3">
                    <c:v>0.334693726055076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ime!$AT$12:$AW$12</c:f>
              <c:strCache>
                <c:ptCount val="4"/>
                <c:pt idx="0">
                  <c:v>MP</c:v>
                </c:pt>
                <c:pt idx="1">
                  <c:v>MGT</c:v>
                </c:pt>
                <c:pt idx="2">
                  <c:v>EP</c:v>
                </c:pt>
                <c:pt idx="3">
                  <c:v>EGT</c:v>
                </c:pt>
              </c:strCache>
            </c:strRef>
          </c:cat>
          <c:val>
            <c:numRef>
              <c:f>Time!$AT$13:$AW$13</c:f>
              <c:numCache>
                <c:formatCode>General</c:formatCode>
                <c:ptCount val="4"/>
                <c:pt idx="0">
                  <c:v>8.7291666666666679</c:v>
                </c:pt>
                <c:pt idx="1">
                  <c:v>8.5861111111111121</c:v>
                </c:pt>
                <c:pt idx="2">
                  <c:v>19.091049382716051</c:v>
                </c:pt>
                <c:pt idx="3">
                  <c:v>19.584876543209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EF7-42D1-BEFE-5BFC3C2E7D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2424216"/>
        <c:axId val="422419296"/>
      </c:barChart>
      <c:catAx>
        <c:axId val="422424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22419296"/>
        <c:crosses val="autoZero"/>
        <c:auto val="1"/>
        <c:lblAlgn val="ctr"/>
        <c:lblOffset val="100"/>
        <c:noMultiLvlLbl val="0"/>
      </c:catAx>
      <c:valAx>
        <c:axId val="422419296"/>
        <c:scaling>
          <c:orientation val="minMax"/>
          <c:max val="2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(h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22424216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BE9-4951-AFA3-AB321C8BBE9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FBE9-4951-AFA3-AB321C8BBE9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BE9-4951-AFA3-AB321C8BBE9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FBE9-4951-AFA3-AB321C8BBE97}"/>
              </c:ext>
            </c:extLst>
          </c:dPt>
          <c:errBars>
            <c:errBarType val="both"/>
            <c:errValType val="cust"/>
            <c:noEndCap val="0"/>
            <c:plus>
              <c:numRef>
                <c:f>glucose!$AO$9:$AO$12</c:f>
                <c:numCache>
                  <c:formatCode>General</c:formatCode>
                  <c:ptCount val="4"/>
                  <c:pt idx="0">
                    <c:v>46.985214699775966</c:v>
                  </c:pt>
                  <c:pt idx="1">
                    <c:v>56.12330033116266</c:v>
                  </c:pt>
                  <c:pt idx="2">
                    <c:v>49.272703834102231</c:v>
                  </c:pt>
                  <c:pt idx="3">
                    <c:v>69.034406070431217</c:v>
                  </c:pt>
                </c:numCache>
              </c:numRef>
            </c:plus>
            <c:minus>
              <c:numRef>
                <c:f>glucose!$AO$9:$AO$12</c:f>
                <c:numCache>
                  <c:formatCode>General</c:formatCode>
                  <c:ptCount val="4"/>
                  <c:pt idx="0">
                    <c:v>46.985214699775966</c:v>
                  </c:pt>
                  <c:pt idx="1">
                    <c:v>56.12330033116266</c:v>
                  </c:pt>
                  <c:pt idx="2">
                    <c:v>49.272703834102231</c:v>
                  </c:pt>
                  <c:pt idx="3">
                    <c:v>69.0344060704312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lucose!$AN$3:$AN$6</c:f>
              <c:strCache>
                <c:ptCount val="4"/>
                <c:pt idx="0">
                  <c:v>MP (Baseline)</c:v>
                </c:pt>
                <c:pt idx="1">
                  <c:v>MP (After 1 week)</c:v>
                </c:pt>
                <c:pt idx="2">
                  <c:v>EP (Baseline)</c:v>
                </c:pt>
                <c:pt idx="3">
                  <c:v>EP (After 1 week)</c:v>
                </c:pt>
              </c:strCache>
            </c:strRef>
          </c:cat>
          <c:val>
            <c:numRef>
              <c:f>glucose!$AO$3:$AO$6</c:f>
              <c:numCache>
                <c:formatCode>General</c:formatCode>
                <c:ptCount val="4"/>
                <c:pt idx="0">
                  <c:v>1068.0401549999999</c:v>
                </c:pt>
                <c:pt idx="1">
                  <c:v>1054.30143</c:v>
                </c:pt>
                <c:pt idx="2">
                  <c:v>1128.4257833333334</c:v>
                </c:pt>
                <c:pt idx="3">
                  <c:v>1201.14388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BE9-4951-AFA3-AB321C8BBE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  <c:max val="1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Glucose AUC (mmol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  <c:majorUnit val="2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991426071741033E-2"/>
          <c:y val="4.8613298337707757E-2"/>
          <c:w val="0.8549046369203851"/>
          <c:h val="0.76991324001166517"/>
        </c:manualLayout>
      </c:layout>
      <c:lineChart>
        <c:grouping val="standard"/>
        <c:varyColors val="0"/>
        <c:ser>
          <c:idx val="0"/>
          <c:order val="0"/>
          <c:tx>
            <c:strRef>
              <c:f>Insuin!$BH$3</c:f>
              <c:strCache>
                <c:ptCount val="1"/>
                <c:pt idx="0">
                  <c:v>MP (Baseline)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Insuin!$BI$11:$BM$11</c:f>
                <c:numCache>
                  <c:formatCode>General</c:formatCode>
                  <c:ptCount val="5"/>
                  <c:pt idx="0">
                    <c:v>0.62696805460485183</c:v>
                  </c:pt>
                  <c:pt idx="1">
                    <c:v>14.030767249605749</c:v>
                  </c:pt>
                  <c:pt idx="2">
                    <c:v>9.5416391381626209</c:v>
                  </c:pt>
                  <c:pt idx="3">
                    <c:v>8.3866051058664439</c:v>
                  </c:pt>
                  <c:pt idx="4">
                    <c:v>6.5602037606684629</c:v>
                  </c:pt>
                </c:numCache>
              </c:numRef>
            </c:plus>
            <c:minus>
              <c:numRef>
                <c:f>Insuin!$BI$11:$BM$11</c:f>
                <c:numCache>
                  <c:formatCode>General</c:formatCode>
                  <c:ptCount val="5"/>
                  <c:pt idx="0">
                    <c:v>0.62696805460485183</c:v>
                  </c:pt>
                  <c:pt idx="1">
                    <c:v>14.030767249605749</c:v>
                  </c:pt>
                  <c:pt idx="2">
                    <c:v>9.5416391381626209</c:v>
                  </c:pt>
                  <c:pt idx="3">
                    <c:v>8.3866051058664439</c:v>
                  </c:pt>
                  <c:pt idx="4">
                    <c:v>6.56020376066846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Insuin!$BI$2:$BM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Insuin!$BI$3:$BM$3</c:f>
              <c:numCache>
                <c:formatCode>General</c:formatCode>
                <c:ptCount val="5"/>
                <c:pt idx="0">
                  <c:v>4.5468244277814822</c:v>
                </c:pt>
                <c:pt idx="1">
                  <c:v>69.602706889400153</c:v>
                </c:pt>
                <c:pt idx="2">
                  <c:v>49.39863190097239</c:v>
                </c:pt>
                <c:pt idx="3">
                  <c:v>42.894974672990521</c:v>
                </c:pt>
                <c:pt idx="4">
                  <c:v>28.7186520563004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5D1-4095-A577-940B7E152832}"/>
            </c:ext>
          </c:extLst>
        </c:ser>
        <c:ser>
          <c:idx val="1"/>
          <c:order val="1"/>
          <c:tx>
            <c:strRef>
              <c:f>Insuin!$BH$4</c:f>
              <c:strCache>
                <c:ptCount val="1"/>
                <c:pt idx="0">
                  <c:v>MP (After 1 week)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Insuin!$BI$12:$BM$12</c:f>
                <c:numCache>
                  <c:formatCode>General</c:formatCode>
                  <c:ptCount val="5"/>
                  <c:pt idx="0">
                    <c:v>1.1461506572327664</c:v>
                  </c:pt>
                  <c:pt idx="1">
                    <c:v>15.377547119705826</c:v>
                  </c:pt>
                  <c:pt idx="2">
                    <c:v>8.353846072100696</c:v>
                  </c:pt>
                  <c:pt idx="3">
                    <c:v>7.5153088662240721</c:v>
                  </c:pt>
                  <c:pt idx="4">
                    <c:v>3.0709504124534894</c:v>
                  </c:pt>
                </c:numCache>
              </c:numRef>
            </c:plus>
            <c:minus>
              <c:numRef>
                <c:f>Insuin!$BI$12:$BM$12</c:f>
                <c:numCache>
                  <c:formatCode>General</c:formatCode>
                  <c:ptCount val="5"/>
                  <c:pt idx="0">
                    <c:v>1.1461506572327664</c:v>
                  </c:pt>
                  <c:pt idx="1">
                    <c:v>15.377547119705826</c:v>
                  </c:pt>
                  <c:pt idx="2">
                    <c:v>8.353846072100696</c:v>
                  </c:pt>
                  <c:pt idx="3">
                    <c:v>7.5153088662240721</c:v>
                  </c:pt>
                  <c:pt idx="4">
                    <c:v>3.07095041245348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Insuin!$BI$2:$BM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Insuin!$BI$4:$BM$4</c:f>
              <c:numCache>
                <c:formatCode>General</c:formatCode>
                <c:ptCount val="5"/>
                <c:pt idx="0">
                  <c:v>4.8072683668350678</c:v>
                </c:pt>
                <c:pt idx="1">
                  <c:v>70.803945335057989</c:v>
                </c:pt>
                <c:pt idx="2">
                  <c:v>53.067617369967692</c:v>
                </c:pt>
                <c:pt idx="3">
                  <c:v>40.806892353939546</c:v>
                </c:pt>
                <c:pt idx="4">
                  <c:v>31.239907208450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5D1-4095-A577-940B7E152832}"/>
            </c:ext>
          </c:extLst>
        </c:ser>
        <c:ser>
          <c:idx val="2"/>
          <c:order val="2"/>
          <c:tx>
            <c:strRef>
              <c:f>Insuin!$BH$5</c:f>
              <c:strCache>
                <c:ptCount val="1"/>
                <c:pt idx="0">
                  <c:v>EP (Baseline)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Insuin!$BI$13:$BM$13</c:f>
                <c:numCache>
                  <c:formatCode>General</c:formatCode>
                  <c:ptCount val="5"/>
                  <c:pt idx="0">
                    <c:v>0.58564189834492497</c:v>
                  </c:pt>
                  <c:pt idx="1">
                    <c:v>2.4757923436905167</c:v>
                  </c:pt>
                  <c:pt idx="2">
                    <c:v>4.7984587482557135</c:v>
                  </c:pt>
                  <c:pt idx="3">
                    <c:v>4.5763854446054317</c:v>
                  </c:pt>
                  <c:pt idx="4">
                    <c:v>4.7925111762027175</c:v>
                  </c:pt>
                </c:numCache>
              </c:numRef>
            </c:plus>
            <c:minus>
              <c:numRef>
                <c:f>Insuin!$BI$13:$BM$13</c:f>
                <c:numCache>
                  <c:formatCode>General</c:formatCode>
                  <c:ptCount val="5"/>
                  <c:pt idx="0">
                    <c:v>0.58564189834492497</c:v>
                  </c:pt>
                  <c:pt idx="1">
                    <c:v>2.4757923436905167</c:v>
                  </c:pt>
                  <c:pt idx="2">
                    <c:v>4.7984587482557135</c:v>
                  </c:pt>
                  <c:pt idx="3">
                    <c:v>4.5763854446054317</c:v>
                  </c:pt>
                  <c:pt idx="4">
                    <c:v>4.79251117620271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Insuin!$BI$2:$BM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Insuin!$BI$5:$BM$5</c:f>
              <c:numCache>
                <c:formatCode>General</c:formatCode>
                <c:ptCount val="5"/>
                <c:pt idx="0">
                  <c:v>4.1382407899215314</c:v>
                </c:pt>
                <c:pt idx="1">
                  <c:v>27.873791864001099</c:v>
                </c:pt>
                <c:pt idx="2">
                  <c:v>29.442346304051654</c:v>
                </c:pt>
                <c:pt idx="3">
                  <c:v>30.79378476972763</c:v>
                </c:pt>
                <c:pt idx="4">
                  <c:v>25.72002595631229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5D1-4095-A577-940B7E152832}"/>
            </c:ext>
          </c:extLst>
        </c:ser>
        <c:ser>
          <c:idx val="3"/>
          <c:order val="3"/>
          <c:tx>
            <c:strRef>
              <c:f>Insuin!$BH$6</c:f>
              <c:strCache>
                <c:ptCount val="1"/>
                <c:pt idx="0">
                  <c:v>EP (After 1 week)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Insuin!$BI$14:$BM$14</c:f>
                <c:numCache>
                  <c:formatCode>General</c:formatCode>
                  <c:ptCount val="5"/>
                  <c:pt idx="0">
                    <c:v>0.40485852045177995</c:v>
                  </c:pt>
                  <c:pt idx="1">
                    <c:v>2.0753573375790491</c:v>
                  </c:pt>
                  <c:pt idx="2">
                    <c:v>4.4919645132655379</c:v>
                  </c:pt>
                  <c:pt idx="3">
                    <c:v>3.9792152485130039</c:v>
                  </c:pt>
                  <c:pt idx="4">
                    <c:v>2.7715562407568335</c:v>
                  </c:pt>
                </c:numCache>
              </c:numRef>
            </c:plus>
            <c:minus>
              <c:numRef>
                <c:f>Insuin!$BI$14:$BM$14</c:f>
                <c:numCache>
                  <c:formatCode>General</c:formatCode>
                  <c:ptCount val="5"/>
                  <c:pt idx="0">
                    <c:v>0.40485852045177995</c:v>
                  </c:pt>
                  <c:pt idx="1">
                    <c:v>2.0753573375790491</c:v>
                  </c:pt>
                  <c:pt idx="2">
                    <c:v>4.4919645132655379</c:v>
                  </c:pt>
                  <c:pt idx="3">
                    <c:v>3.9792152485130039</c:v>
                  </c:pt>
                  <c:pt idx="4">
                    <c:v>2.77155624075683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Insuin!$BI$2:$BM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Insuin!$BI$6:$BM$6</c:f>
              <c:numCache>
                <c:formatCode>General</c:formatCode>
                <c:ptCount val="5"/>
                <c:pt idx="0">
                  <c:v>3.32471343664686</c:v>
                </c:pt>
                <c:pt idx="1">
                  <c:v>22.003211864563763</c:v>
                </c:pt>
                <c:pt idx="2">
                  <c:v>23.209136891631154</c:v>
                </c:pt>
                <c:pt idx="3">
                  <c:v>25.308407720124428</c:v>
                </c:pt>
                <c:pt idx="4">
                  <c:v>20.3720583989858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5D1-4095-A577-940B7E1528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89598824"/>
        <c:axId val="889594232"/>
      </c:lineChart>
      <c:catAx>
        <c:axId val="8895988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ime (m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9594232"/>
        <c:crosses val="autoZero"/>
        <c:auto val="1"/>
        <c:lblAlgn val="ctr"/>
        <c:lblOffset val="100"/>
        <c:noMultiLvlLbl val="0"/>
      </c:catAx>
      <c:valAx>
        <c:axId val="8895942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nsulin (mU/L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95988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68966579177602805"/>
          <c:y val="7.407407407407407E-2"/>
          <c:w val="0.29366754155730534"/>
          <c:h val="0.29380285797608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B94-4AFE-AAC2-9C9F8B66849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B94-4AFE-AAC2-9C9F8B66849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B94-4AFE-AAC2-9C9F8B668494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CB94-4AFE-AAC2-9C9F8B668494}"/>
              </c:ext>
            </c:extLst>
          </c:dPt>
          <c:errBars>
            <c:errBarType val="both"/>
            <c:errValType val="cust"/>
            <c:noEndCap val="0"/>
            <c:plus>
              <c:numRef>
                <c:f>Insuin!$BQ$10:$BQ$13</c:f>
                <c:numCache>
                  <c:formatCode>General</c:formatCode>
                  <c:ptCount val="4"/>
                  <c:pt idx="0">
                    <c:v>1346.6944346449668</c:v>
                  </c:pt>
                  <c:pt idx="1">
                    <c:v>1198.617172957041</c:v>
                  </c:pt>
                  <c:pt idx="2">
                    <c:v>601.85299200297857</c:v>
                  </c:pt>
                  <c:pt idx="3">
                    <c:v>418.80428540506256</c:v>
                  </c:pt>
                </c:numCache>
              </c:numRef>
            </c:plus>
            <c:minus>
              <c:numRef>
                <c:f>Insuin!$BQ$10:$BQ$13</c:f>
                <c:numCache>
                  <c:formatCode>General</c:formatCode>
                  <c:ptCount val="4"/>
                  <c:pt idx="0">
                    <c:v>1346.6944346449668</c:v>
                  </c:pt>
                  <c:pt idx="1">
                    <c:v>1198.617172957041</c:v>
                  </c:pt>
                  <c:pt idx="2">
                    <c:v>601.85299200297857</c:v>
                  </c:pt>
                  <c:pt idx="3">
                    <c:v>418.804285405062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Insuin!$BP$3:$BP$6</c:f>
              <c:strCache>
                <c:ptCount val="4"/>
                <c:pt idx="0">
                  <c:v>MP (Baseline)</c:v>
                </c:pt>
                <c:pt idx="1">
                  <c:v>MP (After 1 week)</c:v>
                </c:pt>
                <c:pt idx="2">
                  <c:v>EP (Baseline)</c:v>
                </c:pt>
                <c:pt idx="3">
                  <c:v>EP (After 1 week)</c:v>
                </c:pt>
              </c:strCache>
            </c:strRef>
          </c:cat>
          <c:val>
            <c:numRef>
              <c:f>Insuin!$BQ$3:$BQ$6</c:f>
              <c:numCache>
                <c:formatCode>General</c:formatCode>
                <c:ptCount val="4"/>
                <c:pt idx="0">
                  <c:v>7814.4800507109294</c:v>
                </c:pt>
                <c:pt idx="1">
                  <c:v>7969.8809246926885</c:v>
                </c:pt>
                <c:pt idx="2">
                  <c:v>4842.4208163242065</c:v>
                </c:pt>
                <c:pt idx="3">
                  <c:v>3884.0444327870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B94-4AFE-AAC2-9C9F8B6684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  <c:max val="10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nsulin AUC </a:t>
                </a:r>
                <a:r>
                  <a:rPr lang="en-US" dirty="0"/>
                  <a:t>(mmol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  <c:majorUnit val="10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69203849518809"/>
          <c:y val="9.6065908428113134E-2"/>
          <c:w val="0.82262314085739285"/>
          <c:h val="0.768756926217556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MEQ!$Z$17</c:f>
              <c:strCache>
                <c:ptCount val="1"/>
                <c:pt idx="0">
                  <c:v>Baselin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EQ!$AA$21:$AD$21</c:f>
                <c:numCache>
                  <c:formatCode>General</c:formatCode>
                  <c:ptCount val="4"/>
                  <c:pt idx="0">
                    <c:v>3.9582543851776073</c:v>
                  </c:pt>
                  <c:pt idx="1">
                    <c:v>4.3082607988736141</c:v>
                  </c:pt>
                  <c:pt idx="2">
                    <c:v>1.624807680927187</c:v>
                  </c:pt>
                  <c:pt idx="3">
                    <c:v>2.2429588042429289</c:v>
                  </c:pt>
                </c:numCache>
              </c:numRef>
            </c:plus>
            <c:minus>
              <c:numRef>
                <c:f>MEQ!$AA$21:$AD$21</c:f>
                <c:numCache>
                  <c:formatCode>General</c:formatCode>
                  <c:ptCount val="4"/>
                  <c:pt idx="0">
                    <c:v>3.9582543851776073</c:v>
                  </c:pt>
                  <c:pt idx="1">
                    <c:v>4.3082607988736141</c:v>
                  </c:pt>
                  <c:pt idx="2">
                    <c:v>1.624807680927187</c:v>
                  </c:pt>
                  <c:pt idx="3">
                    <c:v>2.24295880424292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EQ!$AA$16:$AD$16</c:f>
              <c:strCache>
                <c:ptCount val="4"/>
                <c:pt idx="0">
                  <c:v>MP</c:v>
                </c:pt>
                <c:pt idx="1">
                  <c:v>MGT</c:v>
                </c:pt>
                <c:pt idx="2">
                  <c:v>EP</c:v>
                </c:pt>
                <c:pt idx="3">
                  <c:v>EGT</c:v>
                </c:pt>
              </c:strCache>
            </c:strRef>
          </c:cat>
          <c:val>
            <c:numRef>
              <c:f>MEQ!$AA$17:$AD$17</c:f>
              <c:numCache>
                <c:formatCode>General</c:formatCode>
                <c:ptCount val="4"/>
                <c:pt idx="0">
                  <c:v>45.7</c:v>
                </c:pt>
                <c:pt idx="1">
                  <c:v>52.5</c:v>
                </c:pt>
                <c:pt idx="2">
                  <c:v>47.2</c:v>
                </c:pt>
                <c:pt idx="3">
                  <c:v>49.444444444444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2A-4F38-95D9-8948A805BC8D}"/>
            </c:ext>
          </c:extLst>
        </c:ser>
        <c:ser>
          <c:idx val="1"/>
          <c:order val="1"/>
          <c:tx>
            <c:strRef>
              <c:f>MEQ!$Z$18</c:f>
              <c:strCache>
                <c:ptCount val="1"/>
                <c:pt idx="0">
                  <c:v>After 1 wee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MEQ!$AA$22:$AD$22</c:f>
                <c:numCache>
                  <c:formatCode>General</c:formatCode>
                  <c:ptCount val="4"/>
                  <c:pt idx="0">
                    <c:v>3.7794767421488951</c:v>
                  </c:pt>
                  <c:pt idx="1">
                    <c:v>4.2290004072409859</c:v>
                  </c:pt>
                  <c:pt idx="2">
                    <c:v>1.9194906731850581</c:v>
                  </c:pt>
                  <c:pt idx="3">
                    <c:v>2.4576662622883005</c:v>
                  </c:pt>
                </c:numCache>
              </c:numRef>
            </c:plus>
            <c:minus>
              <c:numRef>
                <c:f>MEQ!$AA$22:$AD$22</c:f>
                <c:numCache>
                  <c:formatCode>General</c:formatCode>
                  <c:ptCount val="4"/>
                  <c:pt idx="0">
                    <c:v>3.7794767421488951</c:v>
                  </c:pt>
                  <c:pt idx="1">
                    <c:v>4.2290004072409859</c:v>
                  </c:pt>
                  <c:pt idx="2">
                    <c:v>1.9194906731850581</c:v>
                  </c:pt>
                  <c:pt idx="3">
                    <c:v>2.4576662622883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EQ!$AA$16:$AD$16</c:f>
              <c:strCache>
                <c:ptCount val="4"/>
                <c:pt idx="0">
                  <c:v>MP</c:v>
                </c:pt>
                <c:pt idx="1">
                  <c:v>MGT</c:v>
                </c:pt>
                <c:pt idx="2">
                  <c:v>EP</c:v>
                </c:pt>
                <c:pt idx="3">
                  <c:v>EGT</c:v>
                </c:pt>
              </c:strCache>
            </c:strRef>
          </c:cat>
          <c:val>
            <c:numRef>
              <c:f>MEQ!$AA$18:$AD$18</c:f>
              <c:numCache>
                <c:formatCode>General</c:formatCode>
                <c:ptCount val="4"/>
                <c:pt idx="0">
                  <c:v>46.8</c:v>
                </c:pt>
                <c:pt idx="1">
                  <c:v>52.8</c:v>
                </c:pt>
                <c:pt idx="2">
                  <c:v>48.2</c:v>
                </c:pt>
                <c:pt idx="3">
                  <c:v>47.888888888888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2A-4F38-95D9-8948A805BC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4756648"/>
        <c:axId val="424757304"/>
      </c:barChart>
      <c:catAx>
        <c:axId val="4247566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24757304"/>
        <c:crosses val="autoZero"/>
        <c:auto val="1"/>
        <c:lblAlgn val="ctr"/>
        <c:lblOffset val="100"/>
        <c:noMultiLvlLbl val="0"/>
      </c:catAx>
      <c:valAx>
        <c:axId val="424757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MEQ</a:t>
                </a:r>
                <a:r>
                  <a:rPr lang="ja-JP"/>
                  <a:t>スコア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4247566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115-4565-A6FD-0A1982744D3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8115-4565-A6FD-0A1982744D3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115-4565-A6FD-0A1982744D3D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8115-4565-A6FD-0A1982744D3D}"/>
              </c:ext>
            </c:extLst>
          </c:dPt>
          <c:errBars>
            <c:errBarType val="both"/>
            <c:errValType val="cust"/>
            <c:noEndCap val="0"/>
            <c:plus>
              <c:numRef>
                <c:f>Gallocatechin!$J$75:$J$78</c:f>
                <c:numCache>
                  <c:formatCode>General</c:formatCode>
                  <c:ptCount val="4"/>
                  <c:pt idx="0">
                    <c:v>51.932214879614833</c:v>
                  </c:pt>
                  <c:pt idx="1">
                    <c:v>49.372234565720134</c:v>
                  </c:pt>
                  <c:pt idx="2">
                    <c:v>52.442172067059914</c:v>
                  </c:pt>
                  <c:pt idx="3">
                    <c:v>61.113468549175963</c:v>
                  </c:pt>
                </c:numCache>
              </c:numRef>
            </c:plus>
            <c:minus>
              <c:numRef>
                <c:f>Gallocatechin!$J$75:$J$78</c:f>
                <c:numCache>
                  <c:formatCode>General</c:formatCode>
                  <c:ptCount val="4"/>
                  <c:pt idx="0">
                    <c:v>51.932214879614833</c:v>
                  </c:pt>
                  <c:pt idx="1">
                    <c:v>49.372234565720134</c:v>
                  </c:pt>
                  <c:pt idx="2">
                    <c:v>52.442172067059914</c:v>
                  </c:pt>
                  <c:pt idx="3">
                    <c:v>61.113468549175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allocatechin!$I$69:$I$72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Gallocatechin!$J$69:$J$72</c:f>
              <c:numCache>
                <c:formatCode>General</c:formatCode>
                <c:ptCount val="4"/>
                <c:pt idx="0">
                  <c:v>669.21945000000005</c:v>
                </c:pt>
                <c:pt idx="1">
                  <c:v>750.4837500000001</c:v>
                </c:pt>
                <c:pt idx="2">
                  <c:v>506.35833333333329</c:v>
                </c:pt>
                <c:pt idx="3">
                  <c:v>544.3998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115-4565-A6FD-0A1982744D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 err="1"/>
                  <a:t>Gallocatechin</a:t>
                </a:r>
                <a:r>
                  <a:rPr lang="en-US" dirty="0"/>
                  <a:t>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FEE-4014-B82C-CB808BBA826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FEE-4014-B82C-CB808BBA826D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FEE-4014-B82C-CB808BBA826D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2FEE-4014-B82C-CB808BBA826D}"/>
              </c:ext>
            </c:extLst>
          </c:dPt>
          <c:errBars>
            <c:errBarType val="both"/>
            <c:errValType val="cust"/>
            <c:noEndCap val="0"/>
            <c:plus>
              <c:numRef>
                <c:f>Epigallocatechin!$J$76:$J$79</c:f>
                <c:numCache>
                  <c:formatCode>General</c:formatCode>
                  <c:ptCount val="4"/>
                  <c:pt idx="0">
                    <c:v>65.56626000467007</c:v>
                  </c:pt>
                  <c:pt idx="1">
                    <c:v>58.303276396136141</c:v>
                  </c:pt>
                  <c:pt idx="2">
                    <c:v>60.20550643305905</c:v>
                  </c:pt>
                  <c:pt idx="3">
                    <c:v>68.823050824528977</c:v>
                  </c:pt>
                </c:numCache>
              </c:numRef>
            </c:plus>
            <c:minus>
              <c:numRef>
                <c:f>Epigallocatechin!$J$76:$J$79</c:f>
                <c:numCache>
                  <c:formatCode>General</c:formatCode>
                  <c:ptCount val="4"/>
                  <c:pt idx="0">
                    <c:v>65.56626000467007</c:v>
                  </c:pt>
                  <c:pt idx="1">
                    <c:v>58.303276396136141</c:v>
                  </c:pt>
                  <c:pt idx="2">
                    <c:v>60.20550643305905</c:v>
                  </c:pt>
                  <c:pt idx="3">
                    <c:v>68.8230508245289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Epigallocatechin!$I$70:$I$73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Epigallocatechin!$J$70:$J$73</c:f>
              <c:numCache>
                <c:formatCode>General</c:formatCode>
                <c:ptCount val="4"/>
                <c:pt idx="0">
                  <c:v>728.07900000000006</c:v>
                </c:pt>
                <c:pt idx="1">
                  <c:v>808.06906499999991</c:v>
                </c:pt>
                <c:pt idx="2">
                  <c:v>532.35333333333324</c:v>
                </c:pt>
                <c:pt idx="3">
                  <c:v>588.33668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FEE-4014-B82C-CB808BBA82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Epigallocatechin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049-4341-8937-FE46B94FDD9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049-4341-8937-FE46B94FDD99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049-4341-8937-FE46B94FDD99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049-4341-8937-FE46B94FDD99}"/>
              </c:ext>
            </c:extLst>
          </c:dPt>
          <c:errBars>
            <c:errBarType val="both"/>
            <c:errValType val="cust"/>
            <c:noEndCap val="0"/>
            <c:plus>
              <c:numRef>
                <c:f>'Epigallocatechin gallate'!$J$75:$J$78</c:f>
                <c:numCache>
                  <c:formatCode>General</c:formatCode>
                  <c:ptCount val="4"/>
                  <c:pt idx="0">
                    <c:v>85.95169022051067</c:v>
                  </c:pt>
                  <c:pt idx="1">
                    <c:v>91.709096627883952</c:v>
                  </c:pt>
                  <c:pt idx="2">
                    <c:v>111.07163412310901</c:v>
                  </c:pt>
                  <c:pt idx="3">
                    <c:v>128.18659965166788</c:v>
                  </c:pt>
                </c:numCache>
              </c:numRef>
            </c:plus>
            <c:minus>
              <c:numRef>
                <c:f>'Epigallocatechin gallate'!$J$75:$J$78</c:f>
                <c:numCache>
                  <c:formatCode>General</c:formatCode>
                  <c:ptCount val="4"/>
                  <c:pt idx="0">
                    <c:v>85.95169022051067</c:v>
                  </c:pt>
                  <c:pt idx="1">
                    <c:v>91.709096627883952</c:v>
                  </c:pt>
                  <c:pt idx="2">
                    <c:v>111.07163412310901</c:v>
                  </c:pt>
                  <c:pt idx="3">
                    <c:v>128.186599651667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pigallocatechin gallate'!$I$69:$I$72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'Epigallocatechin gallate'!$J$69:$J$72</c:f>
              <c:numCache>
                <c:formatCode>General</c:formatCode>
                <c:ptCount val="4"/>
                <c:pt idx="0">
                  <c:v>1496.7367499999996</c:v>
                </c:pt>
                <c:pt idx="1">
                  <c:v>1606.63545</c:v>
                </c:pt>
                <c:pt idx="2">
                  <c:v>1276.2136666666665</c:v>
                </c:pt>
                <c:pt idx="3">
                  <c:v>1530.3111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049-4341-8937-FE46B94FDD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Epigallocatechin gallate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CA4-4FC3-851F-D68467072B3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CA4-4FC3-851F-D68467072B3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CA4-4FC3-851F-D68467072B35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6CA4-4FC3-851F-D68467072B35}"/>
              </c:ext>
            </c:extLst>
          </c:dPt>
          <c:errBars>
            <c:errBarType val="both"/>
            <c:errValType val="cust"/>
            <c:noEndCap val="0"/>
            <c:plus>
              <c:numRef>
                <c:f>'Gallocatechin gallate'!$J$74:$J$77</c:f>
                <c:numCache>
                  <c:formatCode>General</c:formatCode>
                  <c:ptCount val="4"/>
                  <c:pt idx="0">
                    <c:v>15.964473221813519</c:v>
                  </c:pt>
                  <c:pt idx="1">
                    <c:v>22.976002383410766</c:v>
                  </c:pt>
                  <c:pt idx="2">
                    <c:v>20.130036326345767</c:v>
                  </c:pt>
                  <c:pt idx="3">
                    <c:v>23.864834711756277</c:v>
                  </c:pt>
                </c:numCache>
              </c:numRef>
            </c:plus>
            <c:minus>
              <c:numRef>
                <c:f>'Gallocatechin gallate'!$J$74:$J$77</c:f>
                <c:numCache>
                  <c:formatCode>General</c:formatCode>
                  <c:ptCount val="4"/>
                  <c:pt idx="0">
                    <c:v>15.964473221813519</c:v>
                  </c:pt>
                  <c:pt idx="1">
                    <c:v>22.976002383410766</c:v>
                  </c:pt>
                  <c:pt idx="2">
                    <c:v>20.130036326345767</c:v>
                  </c:pt>
                  <c:pt idx="3">
                    <c:v>23.8648347117562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allocatechin gallate'!$I$68:$I$71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'Gallocatechin gallate'!$J$68:$J$71</c:f>
              <c:numCache>
                <c:formatCode>General</c:formatCode>
                <c:ptCount val="4"/>
                <c:pt idx="0">
                  <c:v>343.64549999999997</c:v>
                </c:pt>
                <c:pt idx="1">
                  <c:v>362.11935</c:v>
                </c:pt>
                <c:pt idx="2">
                  <c:v>273.75</c:v>
                </c:pt>
                <c:pt idx="3">
                  <c:v>324.363833333333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CA4-4FC3-851F-D68467072B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  <c:max val="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 err="1"/>
                  <a:t>Gallocatechin</a:t>
                </a:r>
                <a:r>
                  <a:rPr lang="en-US" dirty="0"/>
                  <a:t> gallate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032-42D9-9891-D83298783BE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032-42D9-9891-D83298783BE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032-42D9-9891-D83298783BE7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032-42D9-9891-D83298783BE7}"/>
              </c:ext>
            </c:extLst>
          </c:dPt>
          <c:errBars>
            <c:errBarType val="both"/>
            <c:errValType val="cust"/>
            <c:noEndCap val="0"/>
            <c:plus>
              <c:numRef>
                <c:f>'Epicatechin gallate'!$J$74:$J$77</c:f>
                <c:numCache>
                  <c:formatCode>General</c:formatCode>
                  <c:ptCount val="4"/>
                  <c:pt idx="0">
                    <c:v>34.980899516164669</c:v>
                  </c:pt>
                  <c:pt idx="1">
                    <c:v>31.966917347822143</c:v>
                  </c:pt>
                  <c:pt idx="2">
                    <c:v>43.871583647935211</c:v>
                  </c:pt>
                  <c:pt idx="3">
                    <c:v>54.065978327410328</c:v>
                  </c:pt>
                </c:numCache>
              </c:numRef>
            </c:plus>
            <c:minus>
              <c:numRef>
                <c:f>'Epicatechin gallate'!$J$74:$J$77</c:f>
                <c:numCache>
                  <c:formatCode>General</c:formatCode>
                  <c:ptCount val="4"/>
                  <c:pt idx="0">
                    <c:v>34.980899516164669</c:v>
                  </c:pt>
                  <c:pt idx="1">
                    <c:v>31.966917347822143</c:v>
                  </c:pt>
                  <c:pt idx="2">
                    <c:v>43.871583647935211</c:v>
                  </c:pt>
                  <c:pt idx="3">
                    <c:v>54.0659783274103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Epicatechin gallate'!$I$68:$I$71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'Epicatechin gallate'!$J$68:$J$71</c:f>
              <c:numCache>
                <c:formatCode>General</c:formatCode>
                <c:ptCount val="4"/>
                <c:pt idx="0">
                  <c:v>607.13639999999998</c:v>
                </c:pt>
                <c:pt idx="1">
                  <c:v>627.49664999999993</c:v>
                </c:pt>
                <c:pt idx="2">
                  <c:v>548.74366666666674</c:v>
                </c:pt>
                <c:pt idx="3">
                  <c:v>625.947499999999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032-42D9-9891-D83298783B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  <c:max val="8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Epicatechin gallate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A4C-40DD-A133-EDE6FE57A43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0A4C-40DD-A133-EDE6FE57A43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A4C-40DD-A133-EDE6FE57A43B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0A4C-40DD-A133-EDE6FE57A43B}"/>
              </c:ext>
            </c:extLst>
          </c:dPt>
          <c:errBars>
            <c:errBarType val="both"/>
            <c:errValType val="cust"/>
            <c:noEndCap val="0"/>
            <c:plus>
              <c:numRef>
                <c:f>'Catechin gallate'!$J$74:$J$77</c:f>
                <c:numCache>
                  <c:formatCode>General</c:formatCode>
                  <c:ptCount val="4"/>
                  <c:pt idx="0">
                    <c:v>4.6353831069946292</c:v>
                  </c:pt>
                  <c:pt idx="1">
                    <c:v>5.0005286907986202</c:v>
                  </c:pt>
                  <c:pt idx="2">
                    <c:v>5.4198067135738581</c:v>
                  </c:pt>
                  <c:pt idx="3">
                    <c:v>7.4230338857804128</c:v>
                  </c:pt>
                </c:numCache>
              </c:numRef>
            </c:plus>
            <c:minus>
              <c:numRef>
                <c:f>'Catechin gallate'!$J$74:$J$77</c:f>
                <c:numCache>
                  <c:formatCode>General</c:formatCode>
                  <c:ptCount val="4"/>
                  <c:pt idx="0">
                    <c:v>4.6353831069946292</c:v>
                  </c:pt>
                  <c:pt idx="1">
                    <c:v>5.0005286907986202</c:v>
                  </c:pt>
                  <c:pt idx="2">
                    <c:v>5.4198067135738581</c:v>
                  </c:pt>
                  <c:pt idx="3">
                    <c:v>7.42303388578041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atechin gallate'!$I$68:$I$71</c:f>
              <c:strCache>
                <c:ptCount val="4"/>
                <c:pt idx="0">
                  <c:v>MGT (Baseline)</c:v>
                </c:pt>
                <c:pt idx="1">
                  <c:v>MGT (After 1 week)</c:v>
                </c:pt>
                <c:pt idx="2">
                  <c:v>EGT (Baseline)</c:v>
                </c:pt>
                <c:pt idx="3">
                  <c:v>EGT (After 1 week)</c:v>
                </c:pt>
              </c:strCache>
            </c:strRef>
          </c:cat>
          <c:val>
            <c:numRef>
              <c:f>'Catechin gallate'!$J$68:$J$71</c:f>
              <c:numCache>
                <c:formatCode>General</c:formatCode>
                <c:ptCount val="4"/>
                <c:pt idx="0">
                  <c:v>96.178166666666655</c:v>
                </c:pt>
                <c:pt idx="1">
                  <c:v>96.758999999999986</c:v>
                </c:pt>
                <c:pt idx="2">
                  <c:v>81.492499999999993</c:v>
                </c:pt>
                <c:pt idx="3">
                  <c:v>89.0618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A4C-40DD-A133-EDE6FE57A4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3763928"/>
        <c:axId val="883771144"/>
      </c:barChart>
      <c:catAx>
        <c:axId val="883763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71144"/>
        <c:crosses val="autoZero"/>
        <c:auto val="1"/>
        <c:lblAlgn val="ctr"/>
        <c:lblOffset val="100"/>
        <c:noMultiLvlLbl val="0"/>
      </c:catAx>
      <c:valAx>
        <c:axId val="883771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Catechin gallate AUC (ng/3h/l)</a:t>
                </a:r>
                <a:endParaRPr lang="ja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837639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33092738407699"/>
          <c:y val="4.2592592592592585E-2"/>
          <c:w val="0.85090463692038498"/>
          <c:h val="0.77593394575678043"/>
        </c:manualLayout>
      </c:layout>
      <c:lineChart>
        <c:grouping val="standard"/>
        <c:varyColors val="0"/>
        <c:ser>
          <c:idx val="0"/>
          <c:order val="0"/>
          <c:tx>
            <c:strRef>
              <c:f>glucose!$AG$3</c:f>
              <c:strCache>
                <c:ptCount val="1"/>
                <c:pt idx="0">
                  <c:v>MP (Baseline)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AH$9:$AL$9</c:f>
                <c:numCache>
                  <c:formatCode>General</c:formatCode>
                  <c:ptCount val="5"/>
                  <c:pt idx="0">
                    <c:v>0.11889741541392351</c:v>
                  </c:pt>
                  <c:pt idx="1">
                    <c:v>0.28782052467080566</c:v>
                  </c:pt>
                  <c:pt idx="2">
                    <c:v>0.34902211384572041</c:v>
                  </c:pt>
                  <c:pt idx="3">
                    <c:v>0.29200112619721835</c:v>
                  </c:pt>
                  <c:pt idx="4">
                    <c:v>0.27061085462934048</c:v>
                  </c:pt>
                </c:numCache>
              </c:numRef>
            </c:plus>
            <c:minus>
              <c:numRef>
                <c:f>glucose!$AH$9:$AL$9</c:f>
                <c:numCache>
                  <c:formatCode>General</c:formatCode>
                  <c:ptCount val="5"/>
                  <c:pt idx="0">
                    <c:v>0.11889741541392351</c:v>
                  </c:pt>
                  <c:pt idx="1">
                    <c:v>0.28782052467080566</c:v>
                  </c:pt>
                  <c:pt idx="2">
                    <c:v>0.34902211384572041</c:v>
                  </c:pt>
                  <c:pt idx="3">
                    <c:v>0.29200112619721835</c:v>
                  </c:pt>
                  <c:pt idx="4">
                    <c:v>0.270610854629340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ose!$AH$2:$AL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glucose!$AH$3:$AL$3</c:f>
              <c:numCache>
                <c:formatCode>General</c:formatCode>
                <c:ptCount val="5"/>
                <c:pt idx="0">
                  <c:v>4.8793290000000002</c:v>
                </c:pt>
                <c:pt idx="1">
                  <c:v>7.7825019999999991</c:v>
                </c:pt>
                <c:pt idx="2">
                  <c:v>6.0505899999999988</c:v>
                </c:pt>
                <c:pt idx="3">
                  <c:v>5.4621839999999997</c:v>
                </c:pt>
                <c:pt idx="4">
                  <c:v>5.378918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3CB-4A9C-85D7-926D79C7657F}"/>
            </c:ext>
          </c:extLst>
        </c:ser>
        <c:ser>
          <c:idx val="1"/>
          <c:order val="1"/>
          <c:tx>
            <c:strRef>
              <c:f>glucose!$AG$4</c:f>
              <c:strCache>
                <c:ptCount val="1"/>
                <c:pt idx="0">
                  <c:v>MP (After 1 week)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AH$10:$AL$10</c:f>
                <c:numCache>
                  <c:formatCode>General</c:formatCode>
                  <c:ptCount val="5"/>
                  <c:pt idx="0">
                    <c:v>0.1073990594667073</c:v>
                  </c:pt>
                  <c:pt idx="1">
                    <c:v>0.36606683408300694</c:v>
                  </c:pt>
                  <c:pt idx="2">
                    <c:v>0.52949608877886067</c:v>
                  </c:pt>
                  <c:pt idx="3">
                    <c:v>0.26503078188433543</c:v>
                  </c:pt>
                  <c:pt idx="4">
                    <c:v>0.33277204589194559</c:v>
                  </c:pt>
                </c:numCache>
              </c:numRef>
            </c:plus>
            <c:minus>
              <c:numRef>
                <c:f>glucose!$AH$10:$AL$10</c:f>
                <c:numCache>
                  <c:formatCode>General</c:formatCode>
                  <c:ptCount val="5"/>
                  <c:pt idx="0">
                    <c:v>0.1073990594667073</c:v>
                  </c:pt>
                  <c:pt idx="1">
                    <c:v>0.36606683408300694</c:v>
                  </c:pt>
                  <c:pt idx="2">
                    <c:v>0.52949608877886067</c:v>
                  </c:pt>
                  <c:pt idx="3">
                    <c:v>0.26503078188433543</c:v>
                  </c:pt>
                  <c:pt idx="4">
                    <c:v>0.332772045891945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ose!$AH$2:$AL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glucose!$AH$4:$AL$4</c:f>
              <c:numCache>
                <c:formatCode>General</c:formatCode>
                <c:ptCount val="5"/>
                <c:pt idx="0">
                  <c:v>4.9348389999999993</c:v>
                </c:pt>
                <c:pt idx="1">
                  <c:v>7.5493600000000001</c:v>
                </c:pt>
                <c:pt idx="2">
                  <c:v>6.0561409999999993</c:v>
                </c:pt>
                <c:pt idx="3">
                  <c:v>5.4288779999999992</c:v>
                </c:pt>
                <c:pt idx="4">
                  <c:v>5.1846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3CB-4A9C-85D7-926D79C7657F}"/>
            </c:ext>
          </c:extLst>
        </c:ser>
        <c:ser>
          <c:idx val="2"/>
          <c:order val="2"/>
          <c:tx>
            <c:strRef>
              <c:f>glucose!$AG$5</c:f>
              <c:strCache>
                <c:ptCount val="1"/>
                <c:pt idx="0">
                  <c:v>EP (Baseline)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AH$11:$AL$11</c:f>
                <c:numCache>
                  <c:formatCode>General</c:formatCode>
                  <c:ptCount val="5"/>
                  <c:pt idx="0">
                    <c:v>0.14949706049176689</c:v>
                  </c:pt>
                  <c:pt idx="1">
                    <c:v>0.2801760153627883</c:v>
                  </c:pt>
                  <c:pt idx="2">
                    <c:v>0.56989398899117361</c:v>
                  </c:pt>
                  <c:pt idx="3">
                    <c:v>0.29677523963149993</c:v>
                  </c:pt>
                  <c:pt idx="4">
                    <c:v>0.22366168597148003</c:v>
                  </c:pt>
                </c:numCache>
              </c:numRef>
            </c:plus>
            <c:minus>
              <c:numRef>
                <c:f>glucose!$AH$11:$AL$11</c:f>
                <c:numCache>
                  <c:formatCode>General</c:formatCode>
                  <c:ptCount val="5"/>
                  <c:pt idx="0">
                    <c:v>0.14949706049176689</c:v>
                  </c:pt>
                  <c:pt idx="1">
                    <c:v>0.2801760153627883</c:v>
                  </c:pt>
                  <c:pt idx="2">
                    <c:v>0.56989398899117361</c:v>
                  </c:pt>
                  <c:pt idx="3">
                    <c:v>0.29677523963149993</c:v>
                  </c:pt>
                  <c:pt idx="4">
                    <c:v>0.22366168597148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ose!$AH$2:$AL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glucose!$AH$5:$AL$5</c:f>
              <c:numCache>
                <c:formatCode>General</c:formatCode>
                <c:ptCount val="5"/>
                <c:pt idx="0">
                  <c:v>4.8046988888888889</c:v>
                </c:pt>
                <c:pt idx="1">
                  <c:v>7.0744411111111098</c:v>
                </c:pt>
                <c:pt idx="2">
                  <c:v>6.5995222222222223</c:v>
                </c:pt>
                <c:pt idx="3">
                  <c:v>6.2356233333333329</c:v>
                </c:pt>
                <c:pt idx="4">
                  <c:v>5.766872222222222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3CB-4A9C-85D7-926D79C7657F}"/>
            </c:ext>
          </c:extLst>
        </c:ser>
        <c:ser>
          <c:idx val="3"/>
          <c:order val="3"/>
          <c:tx>
            <c:strRef>
              <c:f>glucose!$AG$6</c:f>
              <c:strCache>
                <c:ptCount val="1"/>
                <c:pt idx="0">
                  <c:v>EP (After 1 week)</c:v>
                </c:pt>
              </c:strCache>
            </c:strRef>
          </c:tx>
          <c:spPr>
            <a:ln w="28575" cap="rnd">
              <a:solidFill>
                <a:schemeClr val="tx1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glucose!$AH$12:$AL$12</c:f>
                <c:numCache>
                  <c:formatCode>General</c:formatCode>
                  <c:ptCount val="5"/>
                  <c:pt idx="0">
                    <c:v>0.12019256658138121</c:v>
                  </c:pt>
                  <c:pt idx="1">
                    <c:v>0.3885822374616219</c:v>
                  </c:pt>
                  <c:pt idx="2">
                    <c:v>0.79248744376799951</c:v>
                  </c:pt>
                  <c:pt idx="3">
                    <c:v>0.33977402736602852</c:v>
                  </c:pt>
                  <c:pt idx="4">
                    <c:v>0.24929956355225555</c:v>
                  </c:pt>
                </c:numCache>
              </c:numRef>
            </c:plus>
            <c:minus>
              <c:numRef>
                <c:f>glucose!$AH$12:$AL$12</c:f>
                <c:numCache>
                  <c:formatCode>General</c:formatCode>
                  <c:ptCount val="5"/>
                  <c:pt idx="0">
                    <c:v>0.12019256658138121</c:v>
                  </c:pt>
                  <c:pt idx="1">
                    <c:v>0.3885822374616219</c:v>
                  </c:pt>
                  <c:pt idx="2">
                    <c:v>0.79248744376799951</c:v>
                  </c:pt>
                  <c:pt idx="3">
                    <c:v>0.33977402736602852</c:v>
                  </c:pt>
                  <c:pt idx="4">
                    <c:v>0.249299563552255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glucose!$AH$2:$AL$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glucose!$AH$6:$AL$6</c:f>
              <c:numCache>
                <c:formatCode>General</c:formatCode>
                <c:ptCount val="5"/>
                <c:pt idx="0">
                  <c:v>4.7615244444444444</c:v>
                </c:pt>
                <c:pt idx="1">
                  <c:v>7.7467288888888879</c:v>
                </c:pt>
                <c:pt idx="2">
                  <c:v>6.877072222222222</c:v>
                </c:pt>
                <c:pt idx="3">
                  <c:v>6.8709044444444443</c:v>
                </c:pt>
                <c:pt idx="4">
                  <c:v>5.8532211111111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3CB-4A9C-85D7-926D79C765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68820968"/>
        <c:axId val="668821952"/>
      </c:lineChart>
      <c:catAx>
        <c:axId val="6688209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Time (min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8821952"/>
        <c:crosses val="autoZero"/>
        <c:auto val="1"/>
        <c:lblAlgn val="ctr"/>
        <c:lblOffset val="100"/>
        <c:noMultiLvlLbl val="0"/>
      </c:catAx>
      <c:valAx>
        <c:axId val="668821952"/>
        <c:scaling>
          <c:orientation val="minMax"/>
          <c:max val="10"/>
          <c:min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Glucose (mmol/l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8820968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tr"/>
      <c:layout>
        <c:manualLayout>
          <c:xMode val="edge"/>
          <c:yMode val="edge"/>
          <c:x val="0.69648556430446196"/>
          <c:y val="9.3518518518518542E-2"/>
          <c:w val="0.30351443569553804"/>
          <c:h val="0.293802857976086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569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1094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54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496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871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33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606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415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54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480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532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79C2FD-8E86-4353-BFD1-D0D941BE337A}" type="datetimeFigureOut">
              <a:rPr kumimoji="1" lang="ja-JP" altLang="en-US" smtClean="0"/>
              <a:t>2019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D87B8-4790-42F9-A6F2-5CDF48FE75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198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3A37427-29CF-4A78-9E6C-30ABE1D7EC9C}"/>
              </a:ext>
            </a:extLst>
          </p:cNvPr>
          <p:cNvGraphicFramePr>
            <a:graphicFrameLocks/>
          </p:cNvGraphicFramePr>
          <p:nvPr/>
        </p:nvGraphicFramePr>
        <p:xfrm>
          <a:off x="-124286" y="145624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AC41977D-3FCB-4343-BBD4-C2C54489742B}"/>
              </a:ext>
            </a:extLst>
          </p:cNvPr>
          <p:cNvGraphicFramePr>
            <a:graphicFrameLocks/>
          </p:cNvGraphicFramePr>
          <p:nvPr/>
        </p:nvGraphicFramePr>
        <p:xfrm>
          <a:off x="4447714" y="145624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9175E3D-55FC-4813-88F2-75C7F3F8D0CB}"/>
              </a:ext>
            </a:extLst>
          </p:cNvPr>
          <p:cNvSpPr/>
          <p:nvPr/>
        </p:nvSpPr>
        <p:spPr>
          <a:xfrm>
            <a:off x="411061" y="587978"/>
            <a:ext cx="5687735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ake time of green tea and placebo beverage and MEQ score for each group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074C3DB1-AC41-4261-BC1E-7EB67632278A}"/>
              </a:ext>
            </a:extLst>
          </p:cNvPr>
          <p:cNvSpPr/>
          <p:nvPr/>
        </p:nvSpPr>
        <p:spPr>
          <a:xfrm>
            <a:off x="346513" y="1334600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0DA5C2E-B2EF-46A9-AB7F-83F4B309ACB4}"/>
              </a:ext>
            </a:extLst>
          </p:cNvPr>
          <p:cNvSpPr/>
          <p:nvPr/>
        </p:nvSpPr>
        <p:spPr>
          <a:xfrm>
            <a:off x="4641677" y="1334599"/>
            <a:ext cx="472227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85362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6851C2D1-4F86-4813-A0F1-FDB7C7BD3B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9076958"/>
              </p:ext>
            </p:extLst>
          </p:nvPr>
        </p:nvGraphicFramePr>
        <p:xfrm>
          <a:off x="35963" y="701966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D7A810CA-0E6D-4C6C-9F88-0F7DFC4635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8516168"/>
              </p:ext>
            </p:extLst>
          </p:nvPr>
        </p:nvGraphicFramePr>
        <p:xfrm>
          <a:off x="3113963" y="693577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E6F056A5-72D9-4E5D-8870-7FF51F08DB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7272314"/>
              </p:ext>
            </p:extLst>
          </p:nvPr>
        </p:nvGraphicFramePr>
        <p:xfrm>
          <a:off x="6066000" y="693577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F42565B2-1830-4FC5-A160-EB6DCF5239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86585268"/>
              </p:ext>
            </p:extLst>
          </p:nvPr>
        </p:nvGraphicFramePr>
        <p:xfrm>
          <a:off x="46277" y="3774784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07C3A313-9A22-4F43-B346-C341D6AFD0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4740425"/>
              </p:ext>
            </p:extLst>
          </p:nvPr>
        </p:nvGraphicFramePr>
        <p:xfrm>
          <a:off x="3113963" y="3765066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08A26B0F-EF93-46FD-8665-53B10A630F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8282658"/>
              </p:ext>
            </p:extLst>
          </p:nvPr>
        </p:nvGraphicFramePr>
        <p:xfrm>
          <a:off x="6066000" y="3776357"/>
          <a:ext cx="3078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8C81F5B-5941-4D20-A91E-FCE961194144}"/>
              </a:ext>
            </a:extLst>
          </p:cNvPr>
          <p:cNvSpPr/>
          <p:nvPr/>
        </p:nvSpPr>
        <p:spPr>
          <a:xfrm>
            <a:off x="180810" y="0"/>
            <a:ext cx="8944306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The AUC of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gallocatechin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(A), epigallocatechin (B), epigallocatechin gallate (C),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gallocatechin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gallate (D), epicatechin gallate (E), and catechin gallate (F). Values are means and standard errors represented by bidirectional bars.</a:t>
            </a:r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387B74E-648E-494D-B34B-3CE870F36B0D}"/>
              </a:ext>
            </a:extLst>
          </p:cNvPr>
          <p:cNvSpPr/>
          <p:nvPr/>
        </p:nvSpPr>
        <p:spPr>
          <a:xfrm>
            <a:off x="205352" y="458685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DAC83EE-6E93-4896-8607-E50B067CDDCC}"/>
              </a:ext>
            </a:extLst>
          </p:cNvPr>
          <p:cNvSpPr/>
          <p:nvPr/>
        </p:nvSpPr>
        <p:spPr>
          <a:xfrm>
            <a:off x="3309843" y="458685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581F2F16-230B-46D4-A8FD-45A57B52214B}"/>
              </a:ext>
            </a:extLst>
          </p:cNvPr>
          <p:cNvSpPr/>
          <p:nvPr/>
        </p:nvSpPr>
        <p:spPr>
          <a:xfrm>
            <a:off x="6261880" y="458684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028AC3D-9AB7-4301-9296-FF4BDD714383}"/>
              </a:ext>
            </a:extLst>
          </p:cNvPr>
          <p:cNvSpPr/>
          <p:nvPr/>
        </p:nvSpPr>
        <p:spPr>
          <a:xfrm>
            <a:off x="205352" y="3521785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0EC67974-493C-4475-B3F5-FAEB689C15A7}"/>
              </a:ext>
            </a:extLst>
          </p:cNvPr>
          <p:cNvSpPr/>
          <p:nvPr/>
        </p:nvSpPr>
        <p:spPr>
          <a:xfrm>
            <a:off x="3309843" y="3521785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107428A8-444B-454E-828C-B00A9076CDC4}"/>
              </a:ext>
            </a:extLst>
          </p:cNvPr>
          <p:cNvSpPr/>
          <p:nvPr/>
        </p:nvSpPr>
        <p:spPr>
          <a:xfrm>
            <a:off x="6261880" y="3519076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898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6F63258-A2DC-49C8-B806-2AB880152A5C}"/>
              </a:ext>
            </a:extLst>
          </p:cNvPr>
          <p:cNvGraphicFramePr>
            <a:graphicFrameLocks/>
          </p:cNvGraphicFramePr>
          <p:nvPr/>
        </p:nvGraphicFramePr>
        <p:xfrm>
          <a:off x="0" y="8858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B798683-9570-479E-A33E-25D2D192DCE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463602"/>
              </p:ext>
            </p:extLst>
          </p:nvPr>
        </p:nvGraphicFramePr>
        <p:xfrm>
          <a:off x="0" y="3810000"/>
          <a:ext cx="437066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7A50069B-BB0E-4914-8709-DEFC8B62BD31}"/>
              </a:ext>
            </a:extLst>
          </p:cNvPr>
          <p:cNvGraphicFramePr>
            <a:graphicFrameLocks/>
          </p:cNvGraphicFramePr>
          <p:nvPr/>
        </p:nvGraphicFramePr>
        <p:xfrm>
          <a:off x="4572000" y="88582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E2E3FC1-165C-4E0B-81A7-B595DC3A23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087731"/>
              </p:ext>
            </p:extLst>
          </p:nvPr>
        </p:nvGraphicFramePr>
        <p:xfrm>
          <a:off x="4370664" y="38100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60CE3831-CC95-460E-86D1-5C4088768467}"/>
              </a:ext>
            </a:extLst>
          </p:cNvPr>
          <p:cNvSpPr/>
          <p:nvPr/>
        </p:nvSpPr>
        <p:spPr>
          <a:xfrm>
            <a:off x="241639" y="27886"/>
            <a:ext cx="8826860" cy="4572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kumimoji="1" lang="en-GB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c</a:t>
            </a:r>
            <a:r>
              <a:rPr lang="en-GB" altLang="ja-JP" sz="1200" dirty="0">
                <a:solidFill>
                  <a:schemeClr val="tx1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oncentrations and incremental area under the curve (AUC) of plasma glucose (A, C) and insulin (B, D) in placebo groups. Values are means and standard errors represented by bidirectional bars.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35BA42C8-3308-4D53-AD61-8D232C98E3AD}"/>
              </a:ext>
            </a:extLst>
          </p:cNvPr>
          <p:cNvSpPr/>
          <p:nvPr/>
        </p:nvSpPr>
        <p:spPr>
          <a:xfrm>
            <a:off x="180185" y="605820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16029D6A-3764-4ABC-9F9B-29C80F4BE8FB}"/>
              </a:ext>
            </a:extLst>
          </p:cNvPr>
          <p:cNvSpPr/>
          <p:nvPr/>
        </p:nvSpPr>
        <p:spPr>
          <a:xfrm>
            <a:off x="4572000" y="644357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CE47775-21EC-4B1B-876B-5252AF2A56D7}"/>
              </a:ext>
            </a:extLst>
          </p:cNvPr>
          <p:cNvSpPr/>
          <p:nvPr/>
        </p:nvSpPr>
        <p:spPr>
          <a:xfrm>
            <a:off x="180185" y="3541876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AABBB4E-5345-4E04-BE84-BD9A3E35A16A}"/>
              </a:ext>
            </a:extLst>
          </p:cNvPr>
          <p:cNvSpPr/>
          <p:nvPr/>
        </p:nvSpPr>
        <p:spPr>
          <a:xfrm>
            <a:off x="4572000" y="3524162"/>
            <a:ext cx="458830" cy="24328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4040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244</Words>
  <Application>Microsoft Office PowerPoint</Application>
  <PresentationFormat>画面に合わせる (4:3)</PresentationFormat>
  <Paragraphs>2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将記 高橋</dc:creator>
  <cp:lastModifiedBy>将記 高橋</cp:lastModifiedBy>
  <cp:revision>4</cp:revision>
  <dcterms:created xsi:type="dcterms:W3CDTF">2019-12-09T08:35:15Z</dcterms:created>
  <dcterms:modified xsi:type="dcterms:W3CDTF">2019-12-17T02:19:22Z</dcterms:modified>
</cp:coreProperties>
</file>